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D32F144-5F98-4E60-81DA-21F135768821}" v="1" dt="2023-08-30T13:37:19.4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9" d="100"/>
          <a:sy n="79" d="100"/>
        </p:scale>
        <p:origin x="1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CD32F144-5F98-4E60-81DA-21F135768821}"/>
    <pc:docChg chg="modSld">
      <pc:chgData name="" userId="" providerId="" clId="Web-{CD32F144-5F98-4E60-81DA-21F135768821}" dt="2023-08-30T13:37:19.430" v="0" actId="20577"/>
      <pc:docMkLst>
        <pc:docMk/>
      </pc:docMkLst>
      <pc:sldChg chg="modSp">
        <pc:chgData name="" userId="" providerId="" clId="Web-{CD32F144-5F98-4E60-81DA-21F135768821}" dt="2023-08-30T13:37:19.430" v="0" actId="20577"/>
        <pc:sldMkLst>
          <pc:docMk/>
          <pc:sldMk cId="3372864545" sldId="256"/>
        </pc:sldMkLst>
        <pc:spChg chg="mod">
          <ac:chgData name="" userId="" providerId="" clId="Web-{CD32F144-5F98-4E60-81DA-21F135768821}" dt="2023-08-30T13:37:19.430" v="0" actId="20577"/>
          <ac:spMkLst>
            <pc:docMk/>
            <pc:sldMk cId="3372864545" sldId="256"/>
            <ac:spMk id="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om du vill redigera mall för underrubrikforma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88536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33939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88530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26941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20928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60833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09181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21484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79577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4984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Redigera format för bakgrundstext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8797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Redigera format för bakgrundstext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6E7C4-7D8B-4A0C-9EC1-DCEC38B9808F}" type="datetimeFigureOut">
              <a:rPr lang="sv-SE" smtClean="0"/>
              <a:t>2025-06-16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2FAA4-65B5-4ECE-AAFB-BC3A3E9CE03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4947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z="180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800" b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3b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: Kaplan Meier survival analysis on </a:t>
            </a:r>
            <a:r>
              <a:rPr lang="en-GB" sz="180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uration of active 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bour in women with </a:t>
            </a:r>
            <a:r>
              <a:rPr lang="en-GB" sz="18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estational</a:t>
            </a:r>
            <a:r>
              <a:rPr lang="en-GB" sz="18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iabetes compared to women with no type of diabetes in induction of labour</a:t>
            </a:r>
            <a:endParaRPr lang="sv-S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Bildobjekt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52637" y="1521724"/>
            <a:ext cx="8086725" cy="523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354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AF83B07080ED4046999E072E00E3CD19" ma:contentTypeVersion="3" ma:contentTypeDescription="Skapa ett nytt dokument." ma:contentTypeScope="" ma:versionID="4a0b2b272e3bdcf2ec20997471c4ca2b">
  <xsd:schema xmlns:xsd="http://www.w3.org/2001/XMLSchema" xmlns:xs="http://www.w3.org/2001/XMLSchema" xmlns:p="http://schemas.microsoft.com/office/2006/metadata/properties" xmlns:ns2="74c8418d-bdb4-40fb-b8b0-519145ff7f89" targetNamespace="http://schemas.microsoft.com/office/2006/metadata/properties" ma:root="true" ma:fieldsID="49f8128f9511c577096a2378380b154d" ns2:_="">
    <xsd:import namespace="74c8418d-bdb4-40fb-b8b0-519145ff7f8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4c8418d-bdb4-40fb-b8b0-519145ff7f8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ehållstyp"/>
        <xsd:element ref="dc:title" minOccurs="0" maxOccurs="1" ma:index="4" ma:displayName="Rubrik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B7708A9-8B6D-4FB7-A1D6-A82E5E5B273F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74c8418d-bdb4-40fb-b8b0-519145ff7f89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9B082E07-E9CE-4D40-AB00-50022F234F4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33B6F0A-8255-4DD7-855A-75924BA9D9B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4c8418d-bdb4-40fb-b8b0-519145ff7f8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29</Words>
  <Application>Microsoft Office PowerPoint</Application>
  <PresentationFormat>Bred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Figure S3b: Kaplan Meier survival analysis on duration of active labour in women with pregestational diabetes compared to women with no type of diabetes in induction of labour</vt:lpstr>
    </vt:vector>
  </TitlesOfParts>
  <Company>Region Östergöt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Xb: Kaplan Meier survival analysis on time in active labour in women with type 1 diabetes compared to women with no (type 1) diabetes in induction of labour</dc:title>
  <dc:creator>Nevander Sofia</dc:creator>
  <cp:lastModifiedBy>Nevander Sofia</cp:lastModifiedBy>
  <cp:revision>18</cp:revision>
  <dcterms:created xsi:type="dcterms:W3CDTF">2023-05-26T07:10:35Z</dcterms:created>
  <dcterms:modified xsi:type="dcterms:W3CDTF">2025-06-16T08:20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F83B07080ED4046999E072E00E3CD19</vt:lpwstr>
  </property>
</Properties>
</file>